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09" r:id="rId2"/>
    <p:sldId id="310" r:id="rId3"/>
  </p:sldIdLst>
  <p:sldSz cx="6858000" cy="9144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CC33"/>
    <a:srgbClr val="FF00FF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891" autoAdjust="0"/>
    <p:restoredTop sz="95394" autoAdjust="0"/>
  </p:normalViewPr>
  <p:slideViewPr>
    <p:cSldViewPr snapToGrid="0">
      <p:cViewPr varScale="1">
        <p:scale>
          <a:sx n="67" d="100"/>
          <a:sy n="67" d="100"/>
        </p:scale>
        <p:origin x="2098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v>Mock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J$20:$J$2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099562111085493</c:v>
                  </c:pt>
                  <c:pt idx="2">
                    <c:v>0.41484212952292943</c:v>
                  </c:pt>
                  <c:pt idx="3">
                    <c:v>2.8520396404701529</c:v>
                  </c:pt>
                  <c:pt idx="4">
                    <c:v>1.6075132519013626</c:v>
                  </c:pt>
                </c:numCache>
              </c:numRef>
            </c:plus>
            <c:minus>
              <c:numRef>
                <c:f>'Sheet1 (2)'!$J$20:$J$2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099562111085493</c:v>
                  </c:pt>
                  <c:pt idx="2">
                    <c:v>0.41484212952292943</c:v>
                  </c:pt>
                  <c:pt idx="3">
                    <c:v>2.8520396404701529</c:v>
                  </c:pt>
                  <c:pt idx="4">
                    <c:v>1.60751325190136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H$20:$H$24</c:f>
              <c:numCache>
                <c:formatCode>General</c:formatCode>
                <c:ptCount val="5"/>
                <c:pt idx="0">
                  <c:v>0.16132749481447337</c:v>
                </c:pt>
                <c:pt idx="1">
                  <c:v>12.111085503572252</c:v>
                </c:pt>
                <c:pt idx="2">
                  <c:v>30.571560267342704</c:v>
                </c:pt>
                <c:pt idx="3">
                  <c:v>42.734501037105325</c:v>
                </c:pt>
                <c:pt idx="4">
                  <c:v>39.715372205577324</c:v>
                </c:pt>
              </c:numCache>
            </c:numRef>
          </c:val>
          <c:smooth val="0"/>
        </c:ser>
        <c:ser>
          <c:idx val="3"/>
          <c:order val="1"/>
          <c:tx>
            <c:v>R-Ras38V</c:v>
          </c:tx>
          <c:spPr>
            <a:ln w="28575" cap="rnd">
              <a:solidFill>
                <a:srgbClr val="3333FF"/>
              </a:solidFill>
              <a:prstDash val="solid"/>
              <a:round/>
            </a:ln>
            <a:effectLst/>
          </c:spPr>
          <c:marker>
            <c:symbol val="square"/>
            <c:size val="5"/>
            <c:spPr>
              <a:solidFill>
                <a:srgbClr val="3333FF"/>
              </a:solidFill>
              <a:ln w="9525">
                <a:solidFill>
                  <a:srgbClr val="3333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M$20:$M$2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5351463470845825</c:v>
                  </c:pt>
                  <c:pt idx="2">
                    <c:v>1.3828070984097647</c:v>
                  </c:pt>
                  <c:pt idx="3">
                    <c:v>0.61650149804102217</c:v>
                  </c:pt>
                  <c:pt idx="4">
                    <c:v>0.72021203042175586</c:v>
                  </c:pt>
                </c:numCache>
              </c:numRef>
            </c:plus>
            <c:minus>
              <c:numRef>
                <c:f>'Sheet1 (2)'!$M$20:$M$2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5351463470845825</c:v>
                  </c:pt>
                  <c:pt idx="2">
                    <c:v>1.3828070984097647</c:v>
                  </c:pt>
                  <c:pt idx="3">
                    <c:v>0.61650149804102217</c:v>
                  </c:pt>
                  <c:pt idx="4">
                    <c:v>0.720212030421755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K$20:$K$24</c:f>
              <c:numCache>
                <c:formatCode>General</c:formatCode>
                <c:ptCount val="5"/>
                <c:pt idx="0">
                  <c:v>0.17285088730122147</c:v>
                </c:pt>
                <c:pt idx="1">
                  <c:v>6.8564185296151186</c:v>
                </c:pt>
                <c:pt idx="2">
                  <c:v>13.251901359760314</c:v>
                </c:pt>
                <c:pt idx="3">
                  <c:v>14.68656372436045</c:v>
                </c:pt>
                <c:pt idx="4">
                  <c:v>21.25489744180686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8333472"/>
        <c:axId val="398334648"/>
      </c:lineChart>
      <c:catAx>
        <c:axId val="398333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98334648"/>
        <c:crosses val="autoZero"/>
        <c:auto val="1"/>
        <c:lblAlgn val="ctr"/>
        <c:lblOffset val="100"/>
        <c:noMultiLvlLbl val="0"/>
      </c:catAx>
      <c:valAx>
        <c:axId val="39833464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Dextran leak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983334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v>Mock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J$25:$J$29</c:f>
                <c:numCache>
                  <c:formatCode>General</c:formatCode>
                  <c:ptCount val="5"/>
                  <c:pt idx="0">
                    <c:v>5.7616962433740529E-3</c:v>
                  </c:pt>
                  <c:pt idx="1">
                    <c:v>1.2963816547591627</c:v>
                  </c:pt>
                  <c:pt idx="2">
                    <c:v>1.3021433510025344</c:v>
                  </c:pt>
                  <c:pt idx="3">
                    <c:v>3.681723899516022</c:v>
                  </c:pt>
                  <c:pt idx="4">
                    <c:v>0.71445033417838022</c:v>
                  </c:pt>
                </c:numCache>
              </c:numRef>
            </c:plus>
            <c:minus>
              <c:numRef>
                <c:f>'Sheet1 (2)'!$J$25:$J$29</c:f>
                <c:numCache>
                  <c:formatCode>General</c:formatCode>
                  <c:ptCount val="5"/>
                  <c:pt idx="0">
                    <c:v>5.7616962433740529E-3</c:v>
                  </c:pt>
                  <c:pt idx="1">
                    <c:v>1.2963816547591627</c:v>
                  </c:pt>
                  <c:pt idx="2">
                    <c:v>1.3021433510025344</c:v>
                  </c:pt>
                  <c:pt idx="3">
                    <c:v>3.681723899516022</c:v>
                  </c:pt>
                  <c:pt idx="4">
                    <c:v>0.714450334178380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H$25:$H$29</c:f>
              <c:numCache>
                <c:formatCode>General</c:formatCode>
                <c:ptCount val="5"/>
                <c:pt idx="0">
                  <c:v>0.16708919105784742</c:v>
                </c:pt>
                <c:pt idx="1">
                  <c:v>18.927172159483753</c:v>
                </c:pt>
                <c:pt idx="2">
                  <c:v>43.062917722977645</c:v>
                </c:pt>
                <c:pt idx="3">
                  <c:v>65.112929246370129</c:v>
                </c:pt>
                <c:pt idx="4">
                  <c:v>67.861258354459551</c:v>
                </c:pt>
              </c:numCache>
            </c:numRef>
          </c:val>
          <c:smooth val="0"/>
        </c:ser>
        <c:ser>
          <c:idx val="3"/>
          <c:order val="1"/>
          <c:tx>
            <c:v>R-Ras38V</c:v>
          </c:tx>
          <c:spPr>
            <a:ln w="28575" cap="rnd">
              <a:solidFill>
                <a:srgbClr val="3333FF"/>
              </a:solidFill>
              <a:prstDash val="solid"/>
              <a:round/>
            </a:ln>
            <a:effectLst/>
          </c:spPr>
          <c:marker>
            <c:symbol val="square"/>
            <c:size val="5"/>
            <c:spPr>
              <a:solidFill>
                <a:srgbClr val="3333FF"/>
              </a:solidFill>
              <a:ln w="9525">
                <a:solidFill>
                  <a:srgbClr val="3333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M$25:$M$29</c:f>
                <c:numCache>
                  <c:formatCode>General</c:formatCode>
                  <c:ptCount val="5"/>
                  <c:pt idx="0">
                    <c:v>5.7616962433740529E-3</c:v>
                  </c:pt>
                  <c:pt idx="1">
                    <c:v>0.68564185296151148</c:v>
                  </c:pt>
                  <c:pt idx="2">
                    <c:v>1.2330029960820459</c:v>
                  </c:pt>
                  <c:pt idx="3">
                    <c:v>2.3507720672966097</c:v>
                  </c:pt>
                  <c:pt idx="4">
                    <c:v>0.10371053238073458</c:v>
                  </c:pt>
                </c:numCache>
              </c:numRef>
            </c:plus>
            <c:minus>
              <c:numRef>
                <c:f>'Sheet1 (2)'!$M$25:$M$29</c:f>
                <c:numCache>
                  <c:formatCode>General</c:formatCode>
                  <c:ptCount val="5"/>
                  <c:pt idx="0">
                    <c:v>5.7616962433740529E-3</c:v>
                  </c:pt>
                  <c:pt idx="1">
                    <c:v>0.68564185296151148</c:v>
                  </c:pt>
                  <c:pt idx="2">
                    <c:v>1.2330029960820459</c:v>
                  </c:pt>
                  <c:pt idx="3">
                    <c:v>2.3507720672966097</c:v>
                  </c:pt>
                  <c:pt idx="4">
                    <c:v>0.103710532380734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K$25:$K$29</c:f>
              <c:numCache>
                <c:formatCode>General</c:formatCode>
                <c:ptCount val="5"/>
                <c:pt idx="0">
                  <c:v>0.16708919105784742</c:v>
                </c:pt>
                <c:pt idx="1">
                  <c:v>16.472689559806405</c:v>
                </c:pt>
                <c:pt idx="2">
                  <c:v>27.81746946300991</c:v>
                </c:pt>
                <c:pt idx="3">
                  <c:v>35.123300299608204</c:v>
                </c:pt>
                <c:pt idx="4">
                  <c:v>39.58285319197972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6378968"/>
        <c:axId val="396377792"/>
      </c:lineChart>
      <c:catAx>
        <c:axId val="396378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96377792"/>
        <c:crosses val="autoZero"/>
        <c:auto val="1"/>
        <c:lblAlgn val="ctr"/>
        <c:lblOffset val="100"/>
        <c:noMultiLvlLbl val="0"/>
      </c:catAx>
      <c:valAx>
        <c:axId val="39637779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Dextran leak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9637896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054106517935258"/>
          <c:y val="8.4876543209876545E-2"/>
          <c:w val="0.57490977690288714"/>
          <c:h val="0.75878353747448235"/>
        </c:manualLayout>
      </c:layout>
      <c:lineChart>
        <c:grouping val="standard"/>
        <c:varyColors val="0"/>
        <c:ser>
          <c:idx val="0"/>
          <c:order val="0"/>
          <c:tx>
            <c:v>DMSO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G$15:$G$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8974418068679437</c:v>
                  </c:pt>
                  <c:pt idx="2">
                    <c:v>0.64530997925789346</c:v>
                  </c:pt>
                  <c:pt idx="3">
                    <c:v>1.1984328186218018</c:v>
                  </c:pt>
                  <c:pt idx="4">
                    <c:v>1.2790965660290379</c:v>
                  </c:pt>
                </c:numCache>
              </c:numRef>
            </c:plus>
            <c:minus>
              <c:numRef>
                <c:f>'Sheet1 (2)'!$G$15:$G$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8974418068679437</c:v>
                  </c:pt>
                  <c:pt idx="2">
                    <c:v>0.64530997925789346</c:v>
                  </c:pt>
                  <c:pt idx="3">
                    <c:v>1.1984328186218018</c:v>
                  </c:pt>
                  <c:pt idx="4">
                    <c:v>1.279096566029037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E$15:$E$19</c:f>
              <c:numCache>
                <c:formatCode>General</c:formatCode>
                <c:ptCount val="5"/>
                <c:pt idx="0">
                  <c:v>0.14980410232772529</c:v>
                </c:pt>
                <c:pt idx="1">
                  <c:v>10.710993316432358</c:v>
                </c:pt>
                <c:pt idx="2">
                  <c:v>20.949527540908043</c:v>
                </c:pt>
                <c:pt idx="3">
                  <c:v>24.395021894445726</c:v>
                </c:pt>
                <c:pt idx="4">
                  <c:v>31.873703618345239</c:v>
                </c:pt>
              </c:numCache>
            </c:numRef>
          </c:val>
          <c:smooth val="0"/>
        </c:ser>
        <c:ser>
          <c:idx val="3"/>
          <c:order val="1"/>
          <c:tx>
            <c:v>FSK</c:v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G$20:$G$24</c:f>
                <c:numCache>
                  <c:formatCode>General</c:formatCode>
                  <c:ptCount val="5"/>
                  <c:pt idx="0">
                    <c:v>5.7616962433740398E-3</c:v>
                  </c:pt>
                  <c:pt idx="1">
                    <c:v>0.11523392486748117</c:v>
                  </c:pt>
                  <c:pt idx="2">
                    <c:v>0.21318276100484113</c:v>
                  </c:pt>
                  <c:pt idx="3">
                    <c:v>0.63954828301451627</c:v>
                  </c:pt>
                  <c:pt idx="4">
                    <c:v>0.55888453560728024</c:v>
                  </c:pt>
                </c:numCache>
              </c:numRef>
            </c:plus>
            <c:minus>
              <c:numRef>
                <c:f>'Sheet1 (2)'!$G$20:$G$24</c:f>
                <c:numCache>
                  <c:formatCode>General</c:formatCode>
                  <c:ptCount val="5"/>
                  <c:pt idx="0">
                    <c:v>5.7616962433740398E-3</c:v>
                  </c:pt>
                  <c:pt idx="1">
                    <c:v>0.11523392486748117</c:v>
                  </c:pt>
                  <c:pt idx="2">
                    <c:v>0.21318276100484113</c:v>
                  </c:pt>
                  <c:pt idx="3">
                    <c:v>0.63954828301451627</c:v>
                  </c:pt>
                  <c:pt idx="4">
                    <c:v>0.55888453560728024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E$20:$E$24</c:f>
              <c:numCache>
                <c:formatCode>General</c:formatCode>
                <c:ptCount val="5"/>
                <c:pt idx="0">
                  <c:v>0.15556579857109931</c:v>
                </c:pt>
                <c:pt idx="1">
                  <c:v>10.589997695321504</c:v>
                </c:pt>
                <c:pt idx="2">
                  <c:v>27.362295459783361</c:v>
                </c:pt>
                <c:pt idx="3">
                  <c:v>31.752707997234385</c:v>
                </c:pt>
                <c:pt idx="4">
                  <c:v>36.972804793731271</c:v>
                </c:pt>
              </c:numCache>
            </c:numRef>
          </c:val>
          <c:smooth val="0"/>
        </c:ser>
        <c:ser>
          <c:idx val="6"/>
          <c:order val="2"/>
          <c:tx>
            <c:v>IBM-X</c:v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1 (2)'!$G$25:$G$29</c:f>
                <c:numCache>
                  <c:formatCode>General</c:formatCode>
                  <c:ptCount val="5"/>
                  <c:pt idx="0">
                    <c:v>5.7616962433740529E-3</c:v>
                  </c:pt>
                  <c:pt idx="1">
                    <c:v>0.25351463470845914</c:v>
                  </c:pt>
                  <c:pt idx="2">
                    <c:v>1.8725512790965657</c:v>
                  </c:pt>
                  <c:pt idx="3">
                    <c:v>6.2744872090343407</c:v>
                  </c:pt>
                  <c:pt idx="4">
                    <c:v>1.8898363678266854</c:v>
                  </c:pt>
                </c:numCache>
              </c:numRef>
            </c:plus>
            <c:minus>
              <c:numRef>
                <c:f>'Sheet1 (2)'!$G$25:$G$29</c:f>
                <c:numCache>
                  <c:formatCode>General</c:formatCode>
                  <c:ptCount val="5"/>
                  <c:pt idx="0">
                    <c:v>5.7616962433740529E-3</c:v>
                  </c:pt>
                  <c:pt idx="1">
                    <c:v>0.25351463470845914</c:v>
                  </c:pt>
                  <c:pt idx="2">
                    <c:v>1.8725512790965657</c:v>
                  </c:pt>
                  <c:pt idx="3">
                    <c:v>6.2744872090343407</c:v>
                  </c:pt>
                  <c:pt idx="4">
                    <c:v>1.8898363678266854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Sheet1 (2)'!$D$15:$D$19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</c:numCache>
            </c:numRef>
          </c:cat>
          <c:val>
            <c:numRef>
              <c:f>'Sheet1 (2)'!$E$25:$E$29</c:f>
              <c:numCache>
                <c:formatCode>General</c:formatCode>
                <c:ptCount val="5"/>
                <c:pt idx="0">
                  <c:v>0.16708919105784742</c:v>
                </c:pt>
                <c:pt idx="1">
                  <c:v>17.388799262502882</c:v>
                </c:pt>
                <c:pt idx="2">
                  <c:v>31.637474072366903</c:v>
                </c:pt>
                <c:pt idx="3">
                  <c:v>55.179764922793275</c:v>
                </c:pt>
                <c:pt idx="4">
                  <c:v>53.7451025581931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6377400"/>
        <c:axId val="396378184"/>
      </c:lineChart>
      <c:catAx>
        <c:axId val="396377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96378184"/>
        <c:crosses val="autoZero"/>
        <c:auto val="1"/>
        <c:lblAlgn val="ctr"/>
        <c:lblOffset val="100"/>
        <c:noMultiLvlLbl val="0"/>
      </c:catAx>
      <c:valAx>
        <c:axId val="3963781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Dextran leak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963774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6909667541557303"/>
          <c:y val="0.328175731505784"/>
          <c:w val="0.21354221347331584"/>
          <c:h val="0.34364792942548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r">
              <a:defRPr sz="1200"/>
            </a:lvl1pPr>
          </a:lstStyle>
          <a:p>
            <a:fld id="{F55F39D5-FBF2-4E03-B860-D6061CEA40EE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3" tIns="45708" rIns="91413" bIns="45708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40" y="4621213"/>
            <a:ext cx="5851525" cy="3779837"/>
          </a:xfrm>
          <a:prstGeom prst="rect">
            <a:avLst/>
          </a:prstGeom>
        </p:spPr>
        <p:txBody>
          <a:bodyPr vert="horz" lIns="91413" tIns="45708" rIns="91413" bIns="45708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r">
              <a:defRPr sz="1200"/>
            </a:lvl1pPr>
          </a:lstStyle>
          <a:p>
            <a:fld id="{A3AF5CD0-6BC9-430B-B562-288C9451AB4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907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820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72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4799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562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215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115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667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368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80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62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428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283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280037" y="8774668"/>
            <a:ext cx="229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390338" y="1955438"/>
            <a:ext cx="3917592" cy="5085442"/>
            <a:chOff x="1390338" y="1955438"/>
            <a:chExt cx="3917592" cy="5085442"/>
          </a:xfrm>
        </p:grpSpPr>
        <p:sp>
          <p:nvSpPr>
            <p:cNvPr id="4" name="TextBox 3"/>
            <p:cNvSpPr txBox="1"/>
            <p:nvPr/>
          </p:nvSpPr>
          <p:spPr>
            <a:xfrm>
              <a:off x="1550070" y="3495500"/>
              <a:ext cx="478976" cy="219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 (min)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50070" y="5141420"/>
              <a:ext cx="478976" cy="219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 (min)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0601554"/>
                </p:ext>
              </p:extLst>
            </p:nvPr>
          </p:nvGraphicFramePr>
          <p:xfrm>
            <a:off x="1558890" y="3749040"/>
            <a:ext cx="374904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13262416"/>
                </p:ext>
              </p:extLst>
            </p:nvPr>
          </p:nvGraphicFramePr>
          <p:xfrm>
            <a:off x="1558890" y="5394960"/>
            <a:ext cx="374904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>
              <a:off x="1550070" y="6786632"/>
              <a:ext cx="478976" cy="219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 (min)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134161" y="3906558"/>
              <a:ext cx="11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K-treated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134161" y="5582815"/>
              <a:ext cx="11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M-X-treated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" name="Chart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05802998"/>
                </p:ext>
              </p:extLst>
            </p:nvPr>
          </p:nvGraphicFramePr>
          <p:xfrm>
            <a:off x="1558890" y="2100190"/>
            <a:ext cx="365760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1390338" y="1955438"/>
              <a:ext cx="419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429678" y="3644924"/>
              <a:ext cx="3803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29678" y="5353622"/>
              <a:ext cx="3803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387092" y="2960488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917576" y="2716117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040257" y="2897381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325744" y="2682302"/>
              <a:ext cx="6559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443384" y="2231554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979916" y="2331099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855987" y="2587029"/>
              <a:ext cx="6559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387092" y="4931701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913321" y="4589538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443384" y="4543301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974405" y="4379844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387092" y="6494693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913321" y="6148975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443384" y="6025864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973447" y="5954047"/>
              <a:ext cx="419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13767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77335" y="472619"/>
            <a:ext cx="5655732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olonge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ignaling increases permeability of microvascular EC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permeability of HDMEC monolayer was determined by using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® chamber system after 48 hours of cell incubation with DMSO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or IBM-X. FITC-dextran (70kDa, 1mg/ml) was added into the upper chamber and fluorescence signal in the lower compartment was measured at different time points. Empty chambers without cells were used as a reference (100% dextran leakage) for percentage calculation. Similar analyses were conducted for the ECs transduced with mock or R-Ras38V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or IBM-X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treated culture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wo-way ANOVA, *p&lt;0.05; **p&lt;0.01; ****p&lt;0.000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161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065</TotalTime>
  <Words>165</Words>
  <Application>Microsoft Office PowerPoint</Application>
  <PresentationFormat>On-screen Show (4:3)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e perrot</dc:creator>
  <cp:lastModifiedBy>Carole Perrot</cp:lastModifiedBy>
  <cp:revision>708</cp:revision>
  <cp:lastPrinted>2018-04-05T19:47:36Z</cp:lastPrinted>
  <dcterms:created xsi:type="dcterms:W3CDTF">2016-03-11T17:24:59Z</dcterms:created>
  <dcterms:modified xsi:type="dcterms:W3CDTF">2018-05-16T19:15:02Z</dcterms:modified>
</cp:coreProperties>
</file>